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01" d="100"/>
          <a:sy n="101" d="100"/>
        </p:scale>
        <p:origin x="-202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56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250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992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18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192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468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692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605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228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203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20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680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66800" y="1066800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 5A</a:t>
            </a:r>
            <a:endParaRPr lang="en-US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869949" y="3701256"/>
          <a:ext cx="7404101" cy="323850"/>
        </p:xfrm>
        <a:graphic>
          <a:graphicData uri="http://schemas.openxmlformats.org/drawingml/2006/table">
            <a:tbl>
              <a:tblPr/>
              <a:tblGrid>
                <a:gridCol w="743777">
                  <a:extLst>
                    <a:ext uri="{9D8B030D-6E8A-4147-A177-3AD203B41FA5}">
                      <a16:colId xmlns:a16="http://schemas.microsoft.com/office/drawing/2014/main" xmlns="" val="1347247027"/>
                    </a:ext>
                  </a:extLst>
                </a:gridCol>
                <a:gridCol w="710108">
                  <a:extLst>
                    <a:ext uri="{9D8B030D-6E8A-4147-A177-3AD203B41FA5}">
                      <a16:colId xmlns:a16="http://schemas.microsoft.com/office/drawing/2014/main" xmlns="" val="3243475801"/>
                    </a:ext>
                  </a:extLst>
                </a:gridCol>
                <a:gridCol w="743777">
                  <a:extLst>
                    <a:ext uri="{9D8B030D-6E8A-4147-A177-3AD203B41FA5}">
                      <a16:colId xmlns:a16="http://schemas.microsoft.com/office/drawing/2014/main" xmlns="" val="3289406464"/>
                    </a:ext>
                  </a:extLst>
                </a:gridCol>
                <a:gridCol w="743777">
                  <a:extLst>
                    <a:ext uri="{9D8B030D-6E8A-4147-A177-3AD203B41FA5}">
                      <a16:colId xmlns:a16="http://schemas.microsoft.com/office/drawing/2014/main" xmlns="" val="901101886"/>
                    </a:ext>
                  </a:extLst>
                </a:gridCol>
                <a:gridCol w="743777">
                  <a:extLst>
                    <a:ext uri="{9D8B030D-6E8A-4147-A177-3AD203B41FA5}">
                      <a16:colId xmlns:a16="http://schemas.microsoft.com/office/drawing/2014/main" xmlns="" val="458192996"/>
                    </a:ext>
                  </a:extLst>
                </a:gridCol>
                <a:gridCol w="743777">
                  <a:extLst>
                    <a:ext uri="{9D8B030D-6E8A-4147-A177-3AD203B41FA5}">
                      <a16:colId xmlns:a16="http://schemas.microsoft.com/office/drawing/2014/main" xmlns="" val="1286414753"/>
                    </a:ext>
                  </a:extLst>
                </a:gridCol>
                <a:gridCol w="743777">
                  <a:extLst>
                    <a:ext uri="{9D8B030D-6E8A-4147-A177-3AD203B41FA5}">
                      <a16:colId xmlns:a16="http://schemas.microsoft.com/office/drawing/2014/main" xmlns="" val="2643456367"/>
                    </a:ext>
                  </a:extLst>
                </a:gridCol>
                <a:gridCol w="743777">
                  <a:extLst>
                    <a:ext uri="{9D8B030D-6E8A-4147-A177-3AD203B41FA5}">
                      <a16:colId xmlns:a16="http://schemas.microsoft.com/office/drawing/2014/main" xmlns="" val="2567771873"/>
                    </a:ext>
                  </a:extLst>
                </a:gridCol>
                <a:gridCol w="743777">
                  <a:extLst>
                    <a:ext uri="{9D8B030D-6E8A-4147-A177-3AD203B41FA5}">
                      <a16:colId xmlns:a16="http://schemas.microsoft.com/office/drawing/2014/main" xmlns="" val="865255544"/>
                    </a:ext>
                  </a:extLst>
                </a:gridCol>
                <a:gridCol w="743777">
                  <a:extLst>
                    <a:ext uri="{9D8B030D-6E8A-4147-A177-3AD203B41FA5}">
                      <a16:colId xmlns:a16="http://schemas.microsoft.com/office/drawing/2014/main" xmlns="" val="374694510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EGFL7B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84707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3571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0169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1855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2274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655223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EGFL7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81654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1532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2256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021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73867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64711295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286000" y="3276600"/>
            <a:ext cx="5038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roup   1                                 2                                      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108683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869949" y="3701256"/>
          <a:ext cx="7404101" cy="323850"/>
        </p:xfrm>
        <a:graphic>
          <a:graphicData uri="http://schemas.openxmlformats.org/drawingml/2006/table">
            <a:tbl>
              <a:tblPr/>
              <a:tblGrid>
                <a:gridCol w="743777">
                  <a:extLst>
                    <a:ext uri="{9D8B030D-6E8A-4147-A177-3AD203B41FA5}">
                      <a16:colId xmlns:a16="http://schemas.microsoft.com/office/drawing/2014/main" xmlns="" val="3347183819"/>
                    </a:ext>
                  </a:extLst>
                </a:gridCol>
                <a:gridCol w="710108">
                  <a:extLst>
                    <a:ext uri="{9D8B030D-6E8A-4147-A177-3AD203B41FA5}">
                      <a16:colId xmlns:a16="http://schemas.microsoft.com/office/drawing/2014/main" xmlns="" val="1004250851"/>
                    </a:ext>
                  </a:extLst>
                </a:gridCol>
                <a:gridCol w="743777">
                  <a:extLst>
                    <a:ext uri="{9D8B030D-6E8A-4147-A177-3AD203B41FA5}">
                      <a16:colId xmlns:a16="http://schemas.microsoft.com/office/drawing/2014/main" xmlns="" val="2281092934"/>
                    </a:ext>
                  </a:extLst>
                </a:gridCol>
                <a:gridCol w="743777">
                  <a:extLst>
                    <a:ext uri="{9D8B030D-6E8A-4147-A177-3AD203B41FA5}">
                      <a16:colId xmlns:a16="http://schemas.microsoft.com/office/drawing/2014/main" xmlns="" val="2147035876"/>
                    </a:ext>
                  </a:extLst>
                </a:gridCol>
                <a:gridCol w="743777">
                  <a:extLst>
                    <a:ext uri="{9D8B030D-6E8A-4147-A177-3AD203B41FA5}">
                      <a16:colId xmlns:a16="http://schemas.microsoft.com/office/drawing/2014/main" xmlns="" val="2588291154"/>
                    </a:ext>
                  </a:extLst>
                </a:gridCol>
                <a:gridCol w="743777">
                  <a:extLst>
                    <a:ext uri="{9D8B030D-6E8A-4147-A177-3AD203B41FA5}">
                      <a16:colId xmlns:a16="http://schemas.microsoft.com/office/drawing/2014/main" xmlns="" val="2852535671"/>
                    </a:ext>
                  </a:extLst>
                </a:gridCol>
                <a:gridCol w="743777">
                  <a:extLst>
                    <a:ext uri="{9D8B030D-6E8A-4147-A177-3AD203B41FA5}">
                      <a16:colId xmlns:a16="http://schemas.microsoft.com/office/drawing/2014/main" xmlns="" val="2512328549"/>
                    </a:ext>
                  </a:extLst>
                </a:gridCol>
                <a:gridCol w="743777">
                  <a:extLst>
                    <a:ext uri="{9D8B030D-6E8A-4147-A177-3AD203B41FA5}">
                      <a16:colId xmlns:a16="http://schemas.microsoft.com/office/drawing/2014/main" xmlns="" val="3072782945"/>
                    </a:ext>
                  </a:extLst>
                </a:gridCol>
                <a:gridCol w="743777">
                  <a:extLst>
                    <a:ext uri="{9D8B030D-6E8A-4147-A177-3AD203B41FA5}">
                      <a16:colId xmlns:a16="http://schemas.microsoft.com/office/drawing/2014/main" xmlns="" val="1365764772"/>
                    </a:ext>
                  </a:extLst>
                </a:gridCol>
                <a:gridCol w="743777">
                  <a:extLst>
                    <a:ext uri="{9D8B030D-6E8A-4147-A177-3AD203B41FA5}">
                      <a16:colId xmlns:a16="http://schemas.microsoft.com/office/drawing/2014/main" xmlns="" val="100822959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miR-1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695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5689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1828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2900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2164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075490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miR-126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2528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7480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12568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6209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817788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22100902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286000" y="3276600"/>
            <a:ext cx="5038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roup   1                                 2                                      3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533400" y="914400"/>
            <a:ext cx="805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 5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193781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40713768"/>
              </p:ext>
            </p:extLst>
          </p:nvPr>
        </p:nvGraphicFramePr>
        <p:xfrm>
          <a:off x="1676400" y="2819400"/>
          <a:ext cx="5842002" cy="1406048"/>
        </p:xfrm>
        <a:graphic>
          <a:graphicData uri="http://schemas.openxmlformats.org/drawingml/2006/table">
            <a:tbl>
              <a:tblPr/>
              <a:tblGrid>
                <a:gridCol w="106966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9539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79539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79539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79539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79539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795390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2866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err="1">
                          <a:effectLst/>
                          <a:latin typeface="Arial"/>
                        </a:rPr>
                        <a:t>sictrl</a:t>
                      </a:r>
                      <a:endParaRPr lang="en-US" sz="12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1103.67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0870.52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2588.52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/>
                        </a:rPr>
                        <a:t>14317.13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5878.65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3929.41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5968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/>
                        </a:rPr>
                        <a:t>silncEGFL7OS </a:t>
                      </a:r>
                      <a:r>
                        <a:rPr lang="en-US" sz="1200" b="1" i="0" u="none" strike="noStrike" dirty="0" smtClean="0">
                          <a:effectLst/>
                          <a:latin typeface="Arial"/>
                        </a:rPr>
                        <a:t>#1</a:t>
                      </a:r>
                      <a:endParaRPr lang="en-US" sz="12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3875.78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2745.88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3541.78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0045.52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7250.11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8335.62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55968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/>
                        </a:rPr>
                        <a:t>silncEGFL7OS </a:t>
                      </a:r>
                      <a:r>
                        <a:rPr lang="en-US" sz="1200" b="1" i="0" u="none" strike="noStrike" dirty="0" smtClean="0">
                          <a:effectLst/>
                          <a:latin typeface="Arial"/>
                        </a:rPr>
                        <a:t>#2</a:t>
                      </a:r>
                      <a:endParaRPr lang="en-US" sz="12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1957.93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2617.15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3320.54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/>
                        </a:rPr>
                        <a:t>7250.11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9256.37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/>
                        </a:rPr>
                        <a:t>8785.60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583745"/>
              </p:ext>
            </p:extLst>
          </p:nvPr>
        </p:nvGraphicFramePr>
        <p:xfrm>
          <a:off x="2743200" y="2514600"/>
          <a:ext cx="4800600" cy="304800"/>
        </p:xfrm>
        <a:graphic>
          <a:graphicData uri="http://schemas.openxmlformats.org/drawingml/2006/table">
            <a:tbl>
              <a:tblPr/>
              <a:tblGrid>
                <a:gridCol w="24003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4003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304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Ad-</a:t>
                      </a:r>
                      <a:r>
                        <a:rPr lang="en-US" sz="1400" b="1" i="0" u="none" strike="noStrike">
                          <a:effectLst/>
                          <a:latin typeface="Symbol"/>
                        </a:rPr>
                        <a:t></a:t>
                      </a:r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-gal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ad-miR-126/EGFL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381000" y="457200"/>
            <a:ext cx="1048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5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745875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98</Words>
  <Application>Microsoft Macintosh PowerPoint</Application>
  <PresentationFormat>On-screen Show (4:3)</PresentationFormat>
  <Paragraphs>68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na</dc:creator>
  <cp:lastModifiedBy>Susanna</cp:lastModifiedBy>
  <cp:revision>5</cp:revision>
  <dcterms:created xsi:type="dcterms:W3CDTF">2018-12-03T10:45:52Z</dcterms:created>
  <dcterms:modified xsi:type="dcterms:W3CDTF">2018-12-03T10:52:35Z</dcterms:modified>
</cp:coreProperties>
</file>